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36" d="100"/>
          <a:sy n="136" d="100"/>
        </p:scale>
        <p:origin x="893" y="-1795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3212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1581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8208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6783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40487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0242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326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352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0144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1538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344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CA7CD3-C08D-4342-B752-3543953D623C}" type="datetimeFigureOut">
              <a:rPr lang="zh-CN" altLang="en-US" smtClean="0"/>
              <a:t>2021/1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17EAB-060A-4B53-AC1A-0E4525C9B086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251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文本框 67">
            <a:extLst>
              <a:ext uri="{FF2B5EF4-FFF2-40B4-BE49-F238E27FC236}">
                <a16:creationId xmlns:a16="http://schemas.microsoft.com/office/drawing/2014/main" id="{BA79FFC1-1223-4CBC-B060-57B583ED07DC}"/>
              </a:ext>
            </a:extLst>
          </p:cNvPr>
          <p:cNvSpPr txBox="1"/>
          <p:nvPr/>
        </p:nvSpPr>
        <p:spPr>
          <a:xfrm>
            <a:off x="2442574" y="3729625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4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04325" y="184432"/>
            <a:ext cx="5976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igure S1</a:t>
            </a:r>
            <a:endParaRPr lang="zh-CN" altLang="en-US" sz="12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18900000">
            <a:off x="1616930" y="3257039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WT-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 rot="18900000">
            <a:off x="1795210" y="3257039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WT-cDNA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8A84279-EC71-4A08-B395-9145DFB20FC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2" t="63184" r="46056" b="7597"/>
          <a:stretch/>
        </p:blipFill>
        <p:spPr>
          <a:xfrm>
            <a:off x="1604145" y="3927108"/>
            <a:ext cx="927100" cy="35713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BE6984E-B115-47A0-862E-D975BA4B3F8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0" t="33362" r="2674" b="30986"/>
          <a:stretch/>
        </p:blipFill>
        <p:spPr>
          <a:xfrm>
            <a:off x="1604144" y="4338477"/>
            <a:ext cx="927101" cy="371475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C326E0F0-79A5-43A8-8C96-71AB15215C9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195" t="49676" r="943" b="27461"/>
          <a:stretch/>
        </p:blipFill>
        <p:spPr>
          <a:xfrm>
            <a:off x="1604145" y="3584848"/>
            <a:ext cx="927100" cy="27943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2" name="文本框 61">
            <a:extLst>
              <a:ext uri="{FF2B5EF4-FFF2-40B4-BE49-F238E27FC236}">
                <a16:creationId xmlns:a16="http://schemas.microsoft.com/office/drawing/2014/main" id="{4FA31F74-F314-47B5-BC8C-5E3C021703F4}"/>
              </a:ext>
            </a:extLst>
          </p:cNvPr>
          <p:cNvSpPr txBox="1"/>
          <p:nvPr/>
        </p:nvSpPr>
        <p:spPr>
          <a:xfrm>
            <a:off x="2442574" y="3852589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5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44AAC61-F005-4768-B3DD-9F5FF954C298}"/>
              </a:ext>
            </a:extLst>
          </p:cNvPr>
          <p:cNvSpPr txBox="1"/>
          <p:nvPr/>
        </p:nvSpPr>
        <p:spPr>
          <a:xfrm>
            <a:off x="2442574" y="3901496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4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F73B63BF-86F3-4B4A-9A30-B1E11A4F42EE}"/>
              </a:ext>
            </a:extLst>
          </p:cNvPr>
          <p:cNvSpPr txBox="1"/>
          <p:nvPr/>
        </p:nvSpPr>
        <p:spPr>
          <a:xfrm>
            <a:off x="2442574" y="3965419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3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14C82ADE-D1E5-40B7-BFBA-E9DC1368FA37}"/>
              </a:ext>
            </a:extLst>
          </p:cNvPr>
          <p:cNvSpPr txBox="1"/>
          <p:nvPr/>
        </p:nvSpPr>
        <p:spPr>
          <a:xfrm>
            <a:off x="2442574" y="4046863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2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0BA5F665-AE65-4C5F-95B3-3D4F8ACFCAEF}"/>
              </a:ext>
            </a:extLst>
          </p:cNvPr>
          <p:cNvSpPr txBox="1"/>
          <p:nvPr/>
        </p:nvSpPr>
        <p:spPr>
          <a:xfrm>
            <a:off x="2442574" y="4132427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1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F3ABEE77-E437-464D-AEBE-923E31A0A8F5}"/>
              </a:ext>
            </a:extLst>
          </p:cNvPr>
          <p:cNvSpPr txBox="1"/>
          <p:nvPr/>
        </p:nvSpPr>
        <p:spPr>
          <a:xfrm>
            <a:off x="2483101" y="3435422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6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5F46FA1F-5272-44C8-B9EB-E4D2EF42399A}"/>
              </a:ext>
            </a:extLst>
          </p:cNvPr>
          <p:cNvSpPr txBox="1"/>
          <p:nvPr/>
        </p:nvSpPr>
        <p:spPr>
          <a:xfrm>
            <a:off x="2442574" y="3679619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5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D8E835E8-CB49-412D-A842-25E24F68E58F}"/>
              </a:ext>
            </a:extLst>
          </p:cNvPr>
          <p:cNvSpPr txBox="1"/>
          <p:nvPr/>
        </p:nvSpPr>
        <p:spPr>
          <a:xfrm>
            <a:off x="2442574" y="3612944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7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116FC959-2677-4308-A771-BCA576BAAC9B}"/>
              </a:ext>
            </a:extLst>
          </p:cNvPr>
          <p:cNvSpPr txBox="1"/>
          <p:nvPr/>
        </p:nvSpPr>
        <p:spPr>
          <a:xfrm>
            <a:off x="2442574" y="3553413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9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681E6869-CCDF-4F23-A62E-D8C19A0CD4F4}"/>
              </a:ext>
            </a:extLst>
          </p:cNvPr>
          <p:cNvSpPr txBox="1"/>
          <p:nvPr/>
        </p:nvSpPr>
        <p:spPr>
          <a:xfrm>
            <a:off x="2442574" y="4388482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5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B9E96D2A-FBE5-4C46-B60A-7ACEB54C7B03}"/>
              </a:ext>
            </a:extLst>
          </p:cNvPr>
          <p:cNvSpPr txBox="1"/>
          <p:nvPr/>
        </p:nvSpPr>
        <p:spPr>
          <a:xfrm>
            <a:off x="2442574" y="4325487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6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C4AF5C93-BD4A-441D-A6FD-74B8FD7E1968}"/>
              </a:ext>
            </a:extLst>
          </p:cNvPr>
          <p:cNvSpPr txBox="1"/>
          <p:nvPr/>
        </p:nvSpPr>
        <p:spPr>
          <a:xfrm>
            <a:off x="2442574" y="4477028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4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F41F8DA6-7654-40EC-B0CC-F1A24EF5837F}"/>
              </a:ext>
            </a:extLst>
          </p:cNvPr>
          <p:cNvSpPr txBox="1"/>
          <p:nvPr/>
        </p:nvSpPr>
        <p:spPr>
          <a:xfrm>
            <a:off x="2442574" y="4571479"/>
            <a:ext cx="4636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- 300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5BF203E7-3D7C-4AC4-B94F-464E738E2C11}"/>
              </a:ext>
            </a:extLst>
          </p:cNvPr>
          <p:cNvSpPr txBox="1"/>
          <p:nvPr/>
        </p:nvSpPr>
        <p:spPr>
          <a:xfrm rot="18900000">
            <a:off x="1963138" y="3257039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apro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B8465D19-AE83-4F8B-AD1D-35E6F55BAB59}"/>
              </a:ext>
            </a:extLst>
          </p:cNvPr>
          <p:cNvSpPr txBox="1"/>
          <p:nvPr/>
        </p:nvSpPr>
        <p:spPr>
          <a:xfrm rot="18900000">
            <a:off x="2064131" y="3120295"/>
            <a:ext cx="103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apro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 spo11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587FA622-C707-4144-8AA9-B0F5315F7D3A}"/>
              </a:ext>
            </a:extLst>
          </p:cNvPr>
          <p:cNvSpPr txBox="1"/>
          <p:nvPr/>
        </p:nvSpPr>
        <p:spPr>
          <a:xfrm>
            <a:off x="1013573" y="3517388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APRO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BD4AA2BA-9AA0-4791-82B6-1EA4BC104F82}"/>
              </a:ext>
            </a:extLst>
          </p:cNvPr>
          <p:cNvSpPr txBox="1"/>
          <p:nvPr/>
        </p:nvSpPr>
        <p:spPr>
          <a:xfrm>
            <a:off x="1013573" y="3857697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SPO1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0E19D765-CD03-4AFD-96BD-CDD4EFBCC826}"/>
              </a:ext>
            </a:extLst>
          </p:cNvPr>
          <p:cNvSpPr txBox="1"/>
          <p:nvPr/>
        </p:nvSpPr>
        <p:spPr>
          <a:xfrm>
            <a:off x="1013573" y="4280760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TWI1</a:t>
            </a:r>
            <a:endParaRPr lang="zh-CN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2D475B9F-BF9D-4B48-851C-4E0CF22EC0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9724388"/>
              </p:ext>
            </p:extLst>
          </p:nvPr>
        </p:nvGraphicFramePr>
        <p:xfrm>
          <a:off x="772569" y="1014453"/>
          <a:ext cx="5312862" cy="152496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72574">
                  <a:extLst>
                    <a:ext uri="{9D8B030D-6E8A-4147-A177-3AD203B41FA5}">
                      <a16:colId xmlns:a16="http://schemas.microsoft.com/office/drawing/2014/main" val="197584014"/>
                    </a:ext>
                  </a:extLst>
                </a:gridCol>
                <a:gridCol w="1173467">
                  <a:extLst>
                    <a:ext uri="{9D8B030D-6E8A-4147-A177-3AD203B41FA5}">
                      <a16:colId xmlns:a16="http://schemas.microsoft.com/office/drawing/2014/main" val="3927444221"/>
                    </a:ext>
                  </a:extLst>
                </a:gridCol>
                <a:gridCol w="3666821">
                  <a:extLst>
                    <a:ext uri="{9D8B030D-6E8A-4147-A177-3AD203B41FA5}">
                      <a16:colId xmlns:a16="http://schemas.microsoft.com/office/drawing/2014/main" val="1109980894"/>
                    </a:ext>
                  </a:extLst>
                </a:gridCol>
              </a:tblGrid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sequence (5'-&gt;3'; adapter sequence for ligation is labelled red)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8105341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ro1_5UTRf2905_Not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TCTAGAGCGGCCG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AAGTTTCTTCTATTTATTTGCTT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0848995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</a:t>
                      </a:r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ro1_5UTRr3652_N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AGGTGCCTGGTACC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TTGTAGTGATTATTAGTGAATTT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9577925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ro1_3UTRf6198_N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ACGTCGCACCATCC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ATTTATTCATATAGTTGTTGTTT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4453954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pro1_3UTRr6942_Not1</a:t>
                      </a:r>
                    </a:p>
                  </a:txBody>
                  <a:tcPr marL="7296" marR="7296" marT="7296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GCGGTGGCGGCCG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GATACACTCACCACTTATTTTTA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5176554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pro1_CDSqf5226</a:t>
                      </a:r>
                    </a:p>
                  </a:txBody>
                  <a:tcPr marL="7296" marR="7296" marT="7296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TCCCTTTATTTATTTGAAAAGCT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3120287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6</a:t>
                      </a:r>
                      <a:endParaRPr lang="en-US" altLang="zh-CN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pro1_CDSqr5966</a:t>
                      </a:r>
                    </a:p>
                  </a:txBody>
                  <a:tcPr marL="7296" marR="7296" marT="7296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AAATCTTCAAAGTCTTAAAACTAAT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9497659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#7</a:t>
                      </a: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wi1_CDSf3018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TTAGCAAGTTTATGAATAAGCTC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203832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#8</a:t>
                      </a: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wi1_CDSr357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AATAGTGTAGTGAGTAGGAGAAGC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3353813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#9</a:t>
                      </a: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po11_CDSf255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ATGCAGAGTAGCAATATATCTC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5678278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#10</a:t>
                      </a: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po11_CDSr282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AATTTTAGTCAAAAAGTTCAAC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4074261"/>
                  </a:ext>
                </a:extLst>
              </a:tr>
            </a:tbl>
          </a:graphicData>
        </a:graphic>
      </p:graphicFrame>
      <p:sp>
        <p:nvSpPr>
          <p:cNvPr id="32" name="文本框 31">
            <a:extLst>
              <a:ext uri="{FF2B5EF4-FFF2-40B4-BE49-F238E27FC236}">
                <a16:creationId xmlns:a16="http://schemas.microsoft.com/office/drawing/2014/main" id="{84840849-A99B-4FD3-BDE2-5CA83FD52F0C}"/>
              </a:ext>
            </a:extLst>
          </p:cNvPr>
          <p:cNvSpPr txBox="1"/>
          <p:nvPr/>
        </p:nvSpPr>
        <p:spPr>
          <a:xfrm>
            <a:off x="204325" y="596419"/>
            <a:ext cx="5976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endParaRPr lang="zh-CN" altLang="en-US" sz="12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99F3EB7-C85D-4A78-ABAF-54DE229B52DA}"/>
              </a:ext>
            </a:extLst>
          </p:cNvPr>
          <p:cNvSpPr txBox="1"/>
          <p:nvPr/>
        </p:nvSpPr>
        <p:spPr>
          <a:xfrm>
            <a:off x="204325" y="2894868"/>
            <a:ext cx="6193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endParaRPr lang="zh-CN" altLang="en-US" sz="12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aphicFrame>
        <p:nvGraphicFramePr>
          <p:cNvPr id="36" name="表格 35">
            <a:extLst>
              <a:ext uri="{FF2B5EF4-FFF2-40B4-BE49-F238E27FC236}">
                <a16:creationId xmlns:a16="http://schemas.microsoft.com/office/drawing/2014/main" id="{A54F9652-FBF5-47AC-8246-A9E01B5E47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9495338"/>
              </p:ext>
            </p:extLst>
          </p:nvPr>
        </p:nvGraphicFramePr>
        <p:xfrm>
          <a:off x="3910111" y="3783863"/>
          <a:ext cx="2175320" cy="6931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6422">
                  <a:extLst>
                    <a:ext uri="{9D8B030D-6E8A-4147-A177-3AD203B41FA5}">
                      <a16:colId xmlns:a16="http://schemas.microsoft.com/office/drawing/2014/main" val="197584014"/>
                    </a:ext>
                  </a:extLst>
                </a:gridCol>
                <a:gridCol w="838799">
                  <a:extLst>
                    <a:ext uri="{9D8B030D-6E8A-4147-A177-3AD203B41FA5}">
                      <a16:colId xmlns:a16="http://schemas.microsoft.com/office/drawing/2014/main" val="3927444221"/>
                    </a:ext>
                  </a:extLst>
                </a:gridCol>
                <a:gridCol w="900099">
                  <a:extLst>
                    <a:ext uri="{9D8B030D-6E8A-4147-A177-3AD203B41FA5}">
                      <a16:colId xmlns:a16="http://schemas.microsoft.com/office/drawing/2014/main" val="1109980894"/>
                    </a:ext>
                  </a:extLst>
                </a:gridCol>
              </a:tblGrid>
              <a:tr h="13863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altLang="zh-CN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ne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US" altLang="zh-CN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ze of </a:t>
                      </a:r>
                      <a:r>
                        <a:rPr lang="en-US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CR </a:t>
                      </a:r>
                      <a:r>
                        <a:rPr lang="en-US" altLang="zh-CN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roduct in bp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8105341"/>
                  </a:ext>
                </a:extLst>
              </a:tr>
              <a:tr h="138633">
                <a:tc vMerge="1">
                  <a:txBody>
                    <a:bodyPr/>
                    <a:lstStyle/>
                    <a:p>
                      <a:pPr algn="ctr" fontAlgn="ctr"/>
                      <a:endParaRPr lang="en-US" altLang="zh-C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DNA</a:t>
                      </a:r>
                      <a:endParaRPr lang="en-US" sz="800" b="0" i="0" u="none" strike="noStrike" dirty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DNA</a:t>
                      </a:r>
                      <a:endParaRPr lang="en-US" sz="800" b="0" i="0" u="none" strike="noStrike" dirty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0848995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PRO1</a:t>
                      </a: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41</a:t>
                      </a: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12</a:t>
                      </a: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9577925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PO11</a:t>
                      </a:r>
                    </a:p>
                  </a:txBody>
                  <a:tcPr marL="7296" marR="7296" marT="7296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50</a:t>
                      </a: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34</a:t>
                      </a: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4453954"/>
                  </a:ext>
                </a:extLst>
              </a:tr>
              <a:tr h="1386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WI1</a:t>
                      </a:r>
                    </a:p>
                  </a:txBody>
                  <a:tcPr marL="7296" marR="7296" marT="729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57</a:t>
                      </a:r>
                    </a:p>
                  </a:txBody>
                  <a:tcPr marL="7296" marR="7296" marT="7296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72</a:t>
                      </a:r>
                    </a:p>
                  </a:txBody>
                  <a:tcPr marL="7296" marR="7296" marT="7296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5176554"/>
                  </a:ext>
                </a:extLst>
              </a:tr>
            </a:tbl>
          </a:graphicData>
        </a:graphic>
      </p:graphicFrame>
      <p:sp>
        <p:nvSpPr>
          <p:cNvPr id="37" name="文本框 36">
            <a:extLst>
              <a:ext uri="{FF2B5EF4-FFF2-40B4-BE49-F238E27FC236}">
                <a16:creationId xmlns:a16="http://schemas.microsoft.com/office/drawing/2014/main" id="{A958609E-2B45-4AD8-A869-25D5C901D686}"/>
              </a:ext>
            </a:extLst>
          </p:cNvPr>
          <p:cNvSpPr txBox="1"/>
          <p:nvPr/>
        </p:nvSpPr>
        <p:spPr>
          <a:xfrm rot="18900000">
            <a:off x="1406225" y="3120295"/>
            <a:ext cx="103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B2E78E7-10E2-45B6-A25F-19360FDF4D4B}"/>
              </a:ext>
            </a:extLst>
          </p:cNvPr>
          <p:cNvSpPr txBox="1"/>
          <p:nvPr/>
        </p:nvSpPr>
        <p:spPr>
          <a:xfrm rot="18900000">
            <a:off x="2225374" y="3120295"/>
            <a:ext cx="10348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8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004A6F7E-5990-4C56-86E7-DEB93F9EFEF1}"/>
              </a:ext>
            </a:extLst>
          </p:cNvPr>
          <p:cNvSpPr/>
          <p:nvPr/>
        </p:nvSpPr>
        <p:spPr>
          <a:xfrm>
            <a:off x="214040" y="4998371"/>
            <a:ext cx="645532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Generation and testing of </a:t>
            </a:r>
            <a:r>
              <a:rPr lang="en-US" altLang="zh-CN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apro1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po11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ouble mutant cells</a:t>
            </a:r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AT" altLang="zh-CN" sz="1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AT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. Sequences of primers used in this study. B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APRO1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SPO11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TWI1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as investigated by RT-PCR, using cDNA samples generated from total RNAs of wild-type (WT)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apro1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l-GR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apro1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po11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t four hours after induction of meiosis. Total RNA samples were treated with DNase before reverse transcription, primer pairs that bind to adjacent exons were used for PCR.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CR products amplified from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Tetrahymena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enomic DNA (gDNA) were used as controls for the size of intron-containing DNA fragments. C. PCR product sizes.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TWI1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served as a control for the correct staging of cell samples. 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91316D35-3065-42F9-8E2E-593890CA05BA}"/>
              </a:ext>
            </a:extLst>
          </p:cNvPr>
          <p:cNvSpPr txBox="1"/>
          <p:nvPr/>
        </p:nvSpPr>
        <p:spPr>
          <a:xfrm>
            <a:off x="3346083" y="2894868"/>
            <a:ext cx="6193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</a:t>
            </a:r>
            <a:endParaRPr lang="zh-CN" altLang="en-US" sz="12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8815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4</Words>
  <Application>Microsoft Office PowerPoint</Application>
  <PresentationFormat>A4-Papier (210 x 297 mm)</PresentationFormat>
  <Paragraphs>7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ao TIAN</dc:creator>
  <cp:lastModifiedBy>Josef</cp:lastModifiedBy>
  <cp:revision>20</cp:revision>
  <dcterms:created xsi:type="dcterms:W3CDTF">2021-10-03T14:37:12Z</dcterms:created>
  <dcterms:modified xsi:type="dcterms:W3CDTF">2021-11-05T17:57:15Z</dcterms:modified>
</cp:coreProperties>
</file>